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4" userDrawn="1">
          <p15:clr>
            <a:srgbClr val="A4A3A4"/>
          </p15:clr>
        </p15:guide>
        <p15:guide id="2" pos="1323" userDrawn="1">
          <p15:clr>
            <a:srgbClr val="A4A3A4"/>
          </p15:clr>
        </p15:guide>
        <p15:guide id="3" orient="horz" pos="414" userDrawn="1">
          <p15:clr>
            <a:srgbClr val="A4A3A4"/>
          </p15:clr>
        </p15:guide>
        <p15:guide id="4" pos="3840" userDrawn="1">
          <p15:clr>
            <a:srgbClr val="A4A3A4"/>
          </p15:clr>
        </p15:guide>
        <p15:guide id="5" orient="horz" pos="1185" userDrawn="1">
          <p15:clr>
            <a:srgbClr val="A4A3A4"/>
          </p15:clr>
        </p15:guide>
        <p15:guide id="6" orient="horz" pos="1049" userDrawn="1">
          <p15:clr>
            <a:srgbClr val="A4A3A4"/>
          </p15:clr>
        </p15:guide>
        <p15:guide id="7" orient="horz" pos="1298" userDrawn="1">
          <p15:clr>
            <a:srgbClr val="A4A3A4"/>
          </p15:clr>
        </p15:guide>
        <p15:guide id="8" orient="horz" pos="3793" userDrawn="1">
          <p15:clr>
            <a:srgbClr val="A4A3A4"/>
          </p15:clr>
        </p15:guide>
        <p15:guide id="9" orient="horz" pos="417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eeJoong Lee" initials="Lee" lastIdx="4" clrIdx="0">
    <p:extLst>
      <p:ext uri="{19B8F6BF-5375-455C-9EA6-DF929625EA0E}">
        <p15:presenceInfo xmlns:p15="http://schemas.microsoft.com/office/powerpoint/2012/main" userId="HeeJoong Le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388" autoAdjust="0"/>
  </p:normalViewPr>
  <p:slideViewPr>
    <p:cSldViewPr snapToGrid="0">
      <p:cViewPr varScale="1">
        <p:scale>
          <a:sx n="85" d="100"/>
          <a:sy n="85" d="100"/>
        </p:scale>
        <p:origin x="490" y="67"/>
      </p:cViewPr>
      <p:guideLst>
        <p:guide orient="horz" pos="164"/>
        <p:guide pos="1323"/>
        <p:guide orient="horz" pos="414"/>
        <p:guide pos="3840"/>
        <p:guide orient="horz" pos="1185"/>
        <p:guide orient="horz" pos="1049"/>
        <p:guide orient="horz" pos="1298"/>
        <p:guide orient="horz" pos="3793"/>
        <p:guide orient="horz" pos="417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B55E22-3B9A-4D2C-A739-37567EA8C95B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29D4F8-23FB-4C07-A8F0-B30230CBB7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2888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29D4F8-23FB-4C07-A8F0-B30230CBB7E6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69577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7551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8296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1993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8757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5972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2864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99583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8805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5639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86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6536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18182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275886"/>
            <a:ext cx="1219199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e 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s of women with endometriosis at last clinic visits </a:t>
            </a:r>
            <a:endParaRPr lang="en-US" altLang="ko-KR" sz="20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cording 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receipt of HRT. </a:t>
            </a:r>
            <a:endParaRPr lang="ko-KR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그룹 4"/>
          <p:cNvGrpSpPr/>
          <p:nvPr/>
        </p:nvGrpSpPr>
        <p:grpSpPr>
          <a:xfrm>
            <a:off x="2667000" y="1461247"/>
            <a:ext cx="6858000" cy="5171328"/>
            <a:chOff x="2707341" y="1666022"/>
            <a:chExt cx="6723530" cy="4966553"/>
          </a:xfrm>
        </p:grpSpPr>
        <p:pic>
          <p:nvPicPr>
            <p:cNvPr id="2" name="그림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07341" y="1674253"/>
              <a:ext cx="3388658" cy="4920070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096000" y="1666022"/>
              <a:ext cx="3334871" cy="496655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4911789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0</TotalTime>
  <Words>20</Words>
  <Application>Microsoft Office PowerPoint</Application>
  <PresentationFormat>와이드스크린</PresentationFormat>
  <Paragraphs>3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Eunjeong Ji</dc:creator>
  <cp:lastModifiedBy>Banghyun Lee</cp:lastModifiedBy>
  <cp:revision>38</cp:revision>
  <dcterms:created xsi:type="dcterms:W3CDTF">2022-01-28T09:16:13Z</dcterms:created>
  <dcterms:modified xsi:type="dcterms:W3CDTF">2023-02-06T09:23:03Z</dcterms:modified>
</cp:coreProperties>
</file>